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858000" cy="9906000" type="A4"/>
  <p:notesSz cx="7559675" cy="10691813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2621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ińkowski Jan" userId="529d16ee-75a8-43c8-99e2-47159a453d44" providerId="ADAL" clId="{FF7A8365-F55A-4090-8A4F-905462A482C7}"/>
    <pc:docChg chg="delSld delMainMaster">
      <pc:chgData name="Bińkowski Jan" userId="529d16ee-75a8-43c8-99e2-47159a453d44" providerId="ADAL" clId="{FF7A8365-F55A-4090-8A4F-905462A482C7}" dt="2023-08-31T09:34:59.427" v="0" actId="47"/>
      <pc:docMkLst>
        <pc:docMk/>
      </pc:docMkLst>
      <pc:sldChg chg="del">
        <pc:chgData name="Bińkowski Jan" userId="529d16ee-75a8-43c8-99e2-47159a453d44" providerId="ADAL" clId="{FF7A8365-F55A-4090-8A4F-905462A482C7}" dt="2023-08-31T09:34:59.427" v="0" actId="47"/>
        <pc:sldMkLst>
          <pc:docMk/>
          <pc:sldMk cId="0" sldId="257"/>
        </pc:sldMkLst>
      </pc:sldChg>
      <pc:sldMasterChg chg="del delSldLayout">
        <pc:chgData name="Bińkowski Jan" userId="529d16ee-75a8-43c8-99e2-47159a453d44" providerId="ADAL" clId="{FF7A8365-F55A-4090-8A4F-905462A482C7}" dt="2023-08-31T09:34:59.427" v="0" actId="47"/>
        <pc:sldMasterMkLst>
          <pc:docMk/>
          <pc:sldMasterMk cId="0" sldId="2147483661"/>
        </pc:sldMasterMkLst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62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63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64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65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66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67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68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69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70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71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72"/>
          </pc:sldLayoutMkLst>
        </pc:sldLayoutChg>
        <pc:sldLayoutChg chg="del">
          <pc:chgData name="Bińkowski Jan" userId="529d16ee-75a8-43c8-99e2-47159a453d44" providerId="ADAL" clId="{FF7A8365-F55A-4090-8A4F-905462A482C7}" dt="2023-08-31T09:34:59.427" v="0" actId="47"/>
          <pc:sldLayoutMkLst>
            <pc:docMk/>
            <pc:sldMasterMk cId="0" sldId="2147483661"/>
            <pc:sldLayoutMk cId="0" sldId="2147483673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256409C5-033C-467A-A581-30EA9938CC24}" type="slidenum">
              <a:t>‹#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142FD293-829C-4B5A-A119-94F4F7809C64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4400" b="0" strike="noStrike" spc="-1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AD213A70-BB20-4257-B085-D382764BFDEA}" type="slidenum">
              <a:t>‹#›</a:t>
            </a:fld>
            <a:endParaRPr/>
          </a:p>
        </p:txBody>
      </p:sp>
      <p:sp>
        <p:nvSpPr>
          <p:cNvPr id="9" name="PlaceHolder 8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4400" b="0" strike="noStrike" spc="-1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FBA2851E-6EF1-490E-A1B2-CF3AE781C2AC}" type="slidenum">
              <a:t>‹#›</a:t>
            </a:fld>
            <a:endParaRPr/>
          </a:p>
        </p:txBody>
      </p:sp>
      <p:sp>
        <p:nvSpPr>
          <p:cNvPr id="11" name="PlaceHolder 10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4400" b="0" strike="noStrike" spc="-1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3200" b="0" strike="noStrike" spc="-1"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2" name="PlaceHolder 4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8776DEFC-103C-47A2-A09C-40EC245E647A}" type="slidenum">
              <a:t>‹#›</a:t>
            </a:fld>
            <a:endParaRPr/>
          </a:p>
        </p:txBody>
      </p:sp>
      <p:sp>
        <p:nvSpPr>
          <p:cNvPr id="3" name="PlaceHolder 5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4400" b="0" strike="noStrike" spc="-1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F33F5EDD-C11B-4B01-8C5D-20D996DFDE4D}" type="slidenum">
              <a:t>‹#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4400" b="0" strike="noStrike" spc="-1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1E2C1097-A738-4C25-ADE5-3455596CBA6C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FDEDA15D-9526-4049-AE18-9A4A7894992D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4920"/>
            <a:ext cx="6171840" cy="76676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32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4E380728-8D1B-4D68-8372-8C8369213A2F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4400" b="0" strike="noStrike" spc="-1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CFF95C98-DFBA-4537-BCCF-982D85E95647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4400" b="0" strike="noStrike" spc="-1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EC96BE95-1D29-4088-B24A-5DF236351EEA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4400" b="0" strike="noStrike" spc="-1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lstStyle/>
          <a:p>
            <a:fld id="{D77E2233-AB53-47CC-A9B7-C0D8C403DA3D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ftr" idx="1"/>
          </p:nvPr>
        </p:nvSpPr>
        <p:spPr>
          <a:xfrm>
            <a:off x="2271600" y="9181440"/>
            <a:ext cx="2310120" cy="523080"/>
          </a:xfrm>
          <a:prstGeom prst="rect">
            <a:avLst/>
          </a:prstGeom>
          <a:noFill/>
          <a:ln w="0">
            <a:noFill/>
          </a:ln>
        </p:spPr>
        <p:txBody>
          <a:bodyPr lIns="90000" tIns="45000" rIns="90000" bIns="45000" anchor="ctr">
            <a:noAutofit/>
          </a:bodyPr>
          <a:lstStyle>
            <a:lvl1pPr algn="ctr">
              <a:lnSpc>
                <a:spcPct val="100000"/>
              </a:lnSpc>
              <a:buNone/>
              <a:defRPr lang="en-US" sz="1400" b="0" strike="noStrike" spc="-1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algn="ctr">
              <a:lnSpc>
                <a:spcPct val="100000"/>
              </a:lnSpc>
              <a:buNone/>
            </a:pPr>
            <a:r>
              <a:rPr lang="en-US" sz="1400" b="0" strike="noStrike" spc="-1">
                <a:solidFill>
                  <a:srgbClr val="000000"/>
                </a:solidFill>
                <a:latin typeface="Times New Roman"/>
                <a:ea typeface="DejaVu Sans"/>
              </a:rPr>
              <a:t>&lt;stopka&gt;</a:t>
            </a:r>
            <a:endParaRPr lang="en-US" sz="1400" b="0" strike="noStrike" spc="-1"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ldNum" idx="2"/>
          </p:nvPr>
        </p:nvSpPr>
        <p:spPr>
          <a:xfrm>
            <a:off x="4843440" y="9181440"/>
            <a:ext cx="1538640" cy="523080"/>
          </a:xfrm>
          <a:prstGeom prst="rect">
            <a:avLst/>
          </a:prstGeom>
          <a:noFill/>
          <a:ln w="0">
            <a:noFill/>
          </a:ln>
        </p:spPr>
        <p:txBody>
          <a:bodyPr lIns="90000" tIns="45000" rIns="90000" bIns="45000" anchor="ctr">
            <a:noAutofit/>
          </a:bodyPr>
          <a:lstStyle>
            <a:lvl1pPr algn="r">
              <a:lnSpc>
                <a:spcPct val="100000"/>
              </a:lnSpc>
              <a:buNone/>
              <a:defRPr lang="en-US" sz="830" b="0" strike="noStrike" spc="-1">
                <a:solidFill>
                  <a:srgbClr val="8B8B8B"/>
                </a:solidFill>
                <a:latin typeface="Calibri"/>
                <a:ea typeface="DejaVu Sans"/>
              </a:defRPr>
            </a:lvl1pPr>
          </a:lstStyle>
          <a:p>
            <a:pPr algn="r">
              <a:lnSpc>
                <a:spcPct val="100000"/>
              </a:lnSpc>
              <a:buNone/>
            </a:pPr>
            <a:fld id="{0A4D9438-6208-4FDB-8227-F6A71A9E764E}" type="slidenum">
              <a:rPr lang="en-US" sz="830" b="0" strike="noStrike" spc="-1">
                <a:solidFill>
                  <a:srgbClr val="8B8B8B"/>
                </a:solidFill>
                <a:latin typeface="Calibri"/>
                <a:ea typeface="DejaVu Sans"/>
              </a:rPr>
              <a:t>‹#›</a:t>
            </a:fld>
            <a:endParaRPr lang="en-US" sz="83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3"/>
          </p:nvPr>
        </p:nvSpPr>
        <p:spPr>
          <a:xfrm>
            <a:off x="471600" y="9181440"/>
            <a:ext cx="1538640" cy="523080"/>
          </a:xfrm>
          <a:prstGeom prst="rect">
            <a:avLst/>
          </a:prstGeom>
          <a:noFill/>
          <a:ln w="0">
            <a:noFill/>
          </a:ln>
        </p:spPr>
        <p:txBody>
          <a:bodyPr lIns="90000" tIns="45000" rIns="90000" bIns="45000" anchor="ctr">
            <a:noAutofit/>
          </a:bodyPr>
          <a:lstStyle>
            <a:lvl1pPr>
              <a:defRPr lang="en-US" sz="1400" b="0" strike="noStrike" spc="-1">
                <a:latin typeface="Times New Roman"/>
              </a:defRPr>
            </a:lvl1pPr>
          </a:lstStyle>
          <a:p>
            <a:r>
              <a:rPr lang="en-US" sz="1400" b="0" strike="noStrike" spc="-1">
                <a:latin typeface="Times New Roman"/>
              </a:rPr>
              <a:t>&lt;data/godzina&gt;</a:t>
            </a:r>
          </a:p>
        </p:txBody>
      </p:sp>
      <p:sp>
        <p:nvSpPr>
          <p:cNvPr id="3" name="PlaceHolder 4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r>
              <a:rPr lang="en-US" sz="4400" b="0" strike="noStrike" spc="-1">
                <a:latin typeface="Arial"/>
              </a:rPr>
              <a:t>Kliknij, aby edytować format tekstu tytułu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Kliknij, aby edytować format tekstu konspektu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Drugi poziom konspektu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rzeci poziom konspektu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Czwarty poziom konspektu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Piąty poziom konspektu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zósty poziom konspektu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ódmy poziom konspektu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Obraz 81"/>
          <p:cNvPicPr/>
          <p:nvPr/>
        </p:nvPicPr>
        <p:blipFill>
          <a:blip r:embed="rId2"/>
          <a:stretch/>
        </p:blipFill>
        <p:spPr>
          <a:xfrm>
            <a:off x="360" y="0"/>
            <a:ext cx="6856200" cy="5517720"/>
          </a:xfrm>
          <a:prstGeom prst="rect">
            <a:avLst/>
          </a:prstGeom>
          <a:ln w="0">
            <a:noFill/>
          </a:ln>
        </p:spPr>
      </p:pic>
      <p:sp>
        <p:nvSpPr>
          <p:cNvPr id="83" name="Prostokąt 82"/>
          <p:cNvSpPr/>
          <p:nvPr/>
        </p:nvSpPr>
        <p:spPr>
          <a:xfrm>
            <a:off x="0" y="5416560"/>
            <a:ext cx="6875640" cy="7660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noAutofit/>
          </a:bodyPr>
          <a:lstStyle/>
          <a:p>
            <a:pPr algn="just">
              <a:lnSpc>
                <a:spcPct val="100000"/>
              </a:lnSpc>
              <a:buNone/>
            </a:pPr>
            <a:r>
              <a:rPr lang="en-GB" sz="1200" b="0" strike="noStrike" spc="-1">
                <a:solidFill>
                  <a:srgbClr val="000000"/>
                </a:solidFill>
                <a:latin typeface="Times New Roman"/>
                <a:ea typeface="Calibri"/>
              </a:rPr>
              <a:t>Supplementary Figure 1: The results of tissue specificity gene expression analysis performed with FUMA platform and based on "GTEx v8: 54 tissue types database" for a set of 369 DEGs identified between the healthy breast tissue and breast infiltrating duct carcinoma. The red colour indicates statistical significance at the 0.05 level.</a:t>
            </a:r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23</TotalTime>
  <Words>57</Words>
  <Application>Microsoft Office PowerPoint</Application>
  <PresentationFormat>Papier A4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5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7" baseType="lpstr">
      <vt:lpstr>Arial</vt:lpstr>
      <vt:lpstr>Calibri</vt:lpstr>
      <vt:lpstr>Symbol</vt:lpstr>
      <vt:lpstr>Times New Roman</vt:lpstr>
      <vt:lpstr>Wingdings</vt:lpstr>
      <vt:lpstr>Office Theme</vt:lpstr>
      <vt:lpstr>Prezentacja programu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/>
  <dc:description/>
  <cp:lastModifiedBy>Bińkowski Jan</cp:lastModifiedBy>
  <cp:revision>331</cp:revision>
  <dcterms:created xsi:type="dcterms:W3CDTF">2023-03-05T10:29:33Z</dcterms:created>
  <dcterms:modified xsi:type="dcterms:W3CDTF">2023-08-31T14:19:00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A4 Paper (210x297 mm)</vt:lpwstr>
  </property>
  <property fmtid="{D5CDD505-2E9C-101B-9397-08002B2CF9AE}" pid="3" name="Slides">
    <vt:i4>3</vt:i4>
  </property>
</Properties>
</file>